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0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794367-FAE3-2B44-ADF1-AED97128A569}" type="datetimeFigureOut">
              <a:rPr kumimoji="1" lang="ja-JP" altLang="en-US" smtClean="0"/>
              <a:t>2026/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D2A58D-C18E-154B-9000-37843AC8BE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6809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A6E562-CA7E-9F4D-8BBD-072145F7BB7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99393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EC5189-BEFE-213E-EBD7-EAC2F366E64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A199DE0-D0C2-D5CF-E84F-85C6405481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E87768-E716-E03E-E65B-F068E578F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6AB1F-7CD1-8E4F-B3B4-9FCEEB366A8C}" type="datetimeFigureOut">
              <a:rPr kumimoji="1" lang="ja-JP" altLang="en-US" smtClean="0"/>
              <a:t>2026/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514E5A-D26E-696E-F80B-783E90016D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C289602-FF18-1B8A-E1D5-2F8B61F0EC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90B9B-582B-1E4A-8C18-55FF3673A6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0933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F9ED9C-C786-C28E-F9FE-0F41F082B4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7103A81-156B-4C5C-8F22-21FAC36D56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D7656F9-4CF4-72E9-171C-B6D4ED903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6AB1F-7CD1-8E4F-B3B4-9FCEEB366A8C}" type="datetimeFigureOut">
              <a:rPr kumimoji="1" lang="ja-JP" altLang="en-US" smtClean="0"/>
              <a:t>2026/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CD79E04-7194-8A74-69C4-818D4B78C0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54BE4AC-89B0-9A2A-0858-F20D74A9E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90B9B-582B-1E4A-8C18-55FF3673A6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2445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A138479-93A6-208B-F12A-9DB0881084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94953FE-5AB7-779E-906A-F746A4E2FA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2D12DEE-D521-E8D8-7D3C-E3799050A8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6AB1F-7CD1-8E4F-B3B4-9FCEEB366A8C}" type="datetimeFigureOut">
              <a:rPr kumimoji="1" lang="ja-JP" altLang="en-US" smtClean="0"/>
              <a:t>2026/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4DE5B96-56F5-F213-9794-12960DC43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4505BD6-4F7A-18E2-3C51-50ECA7FCFF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90B9B-582B-1E4A-8C18-55FF3673A6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5001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5C7024-EAC0-9EA9-AC76-832ABD577A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47428D4-4439-0A8B-115A-663B54CFDB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C2CC86-02E1-515E-B5FF-031E954CDF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6AB1F-7CD1-8E4F-B3B4-9FCEEB366A8C}" type="datetimeFigureOut">
              <a:rPr kumimoji="1" lang="ja-JP" altLang="en-US" smtClean="0"/>
              <a:t>2026/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90DFE42-44DF-51F1-AD46-DA1C4687F6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5A3007-5B6F-0F75-5687-C478219E2D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90B9B-582B-1E4A-8C18-55FF3673A6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4203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E2E71F-B5C3-9AA3-C687-542C080133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B08EA33-FBF2-2559-83BD-28A0321EDC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5803F23-615E-BCFA-AB77-3E60CEB1D9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6AB1F-7CD1-8E4F-B3B4-9FCEEB366A8C}" type="datetimeFigureOut">
              <a:rPr kumimoji="1" lang="ja-JP" altLang="en-US" smtClean="0"/>
              <a:t>2026/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97D6130-D515-CF44-4798-B93A79090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7B2D3F0-5A07-0A3D-B9C6-47124905B2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90B9B-582B-1E4A-8C18-55FF3673A6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6272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D47747-F4A4-B818-7B39-322FE5CD9E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AE7F56D-3C8D-D3F9-FA9D-181CACAB61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56763E0-8F0F-13DD-E5C2-53CE67FAB5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A7B3622-01B7-16AD-AB25-665170232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6AB1F-7CD1-8E4F-B3B4-9FCEEB366A8C}" type="datetimeFigureOut">
              <a:rPr kumimoji="1" lang="ja-JP" altLang="en-US" smtClean="0"/>
              <a:t>2026/1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D64AAA8-76C5-7C50-A9C6-8E9918D5A5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63B2EDB-309C-BA3D-83D9-C6B06E45A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90B9B-582B-1E4A-8C18-55FF3673A6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6756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E35A24-44AB-7D8A-7ABE-721DD69D40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5AF7866-3E3A-E113-88FB-A6C872A429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00B7069-6417-4F66-654F-BDB9C00969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730DAB5-4AE4-5FE6-62FD-22A0979901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19E9533-3323-0DD9-5031-ACE4AA47BE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2CC00C6-BF0F-1F4F-9DC5-3B0F6A7E24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6AB1F-7CD1-8E4F-B3B4-9FCEEB366A8C}" type="datetimeFigureOut">
              <a:rPr kumimoji="1" lang="ja-JP" altLang="en-US" smtClean="0"/>
              <a:t>2026/1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0F54069-5E1C-F02C-02D9-6F2D23F139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AB632DB-237B-F5BE-89CD-B3A92AE916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90B9B-582B-1E4A-8C18-55FF3673A6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8581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CE2705-E60B-4627-F8F5-47D83F6AC8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009333D-4487-5670-98DB-D2EE41D0D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6AB1F-7CD1-8E4F-B3B4-9FCEEB366A8C}" type="datetimeFigureOut">
              <a:rPr kumimoji="1" lang="ja-JP" altLang="en-US" smtClean="0"/>
              <a:t>2026/1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E148213-8F6F-846C-4EA4-9E5807463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2534B72-B6FC-CA44-6F54-67BB7F4FFA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90B9B-582B-1E4A-8C18-55FF3673A6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6873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B4D76A8-8BFE-A7D1-8E6C-C656905F8F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6AB1F-7CD1-8E4F-B3B4-9FCEEB366A8C}" type="datetimeFigureOut">
              <a:rPr kumimoji="1" lang="ja-JP" altLang="en-US" smtClean="0"/>
              <a:t>2026/1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C800416-0F61-6523-EF76-E973D742E4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414EE63-8EBC-3674-8DC2-7E4A464216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90B9B-582B-1E4A-8C18-55FF3673A6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9567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1D9CED9-3F1A-0A23-063C-264B302B05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A317E8E-8D16-DD4A-BA00-429E193D7E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6DDC889-4AC1-6074-99EE-60D0149AC2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B4A414B-1EA7-BCFE-66A3-9463767DB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6AB1F-7CD1-8E4F-B3B4-9FCEEB366A8C}" type="datetimeFigureOut">
              <a:rPr kumimoji="1" lang="ja-JP" altLang="en-US" smtClean="0"/>
              <a:t>2026/1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782D4A2-5745-0508-4DD8-B65F550CB0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F8B8036-44A9-819F-CB2E-304D1D34E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90B9B-582B-1E4A-8C18-55FF3673A6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6705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8CE6B6-20AD-8256-5995-6CD9E921F0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F7AD584-82E0-86DB-A082-48B87B3484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CD1B04B-F1C5-4D9A-321A-08037F5A20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3268EF8-B9EA-DCF1-3754-EEF348045F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6AB1F-7CD1-8E4F-B3B4-9FCEEB366A8C}" type="datetimeFigureOut">
              <a:rPr kumimoji="1" lang="ja-JP" altLang="en-US" smtClean="0"/>
              <a:t>2026/1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3BDA4AF-972A-3735-D8DB-05E1538B95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F505D1F-8F93-A615-23A3-332D1F56AF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90B9B-582B-1E4A-8C18-55FF3673A6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4421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2D78162-752C-0008-18AA-D78813DF40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47759F0-878A-B63C-9153-DE0C4894A4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D5D5777-9B1B-A118-0339-7BF93EAD5B1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E96AB1F-7CD1-8E4F-B3B4-9FCEEB366A8C}" type="datetimeFigureOut">
              <a:rPr kumimoji="1" lang="ja-JP" altLang="en-US" smtClean="0"/>
              <a:t>2026/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319F082-A986-DA1D-A557-AF2131C96F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93BD5A9-7B72-507E-25E0-1CAA278DD1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5D90B9B-582B-1E4A-8C18-55FF3673A6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6509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 descr="グラフ, 折れ線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46BC9561-C62A-D9B5-6387-E0F5A67F753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6200" y="1325563"/>
            <a:ext cx="4267200" cy="4267200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401A336-E833-AD43-D7DA-ED4CE33A30D1}"/>
              </a:ext>
            </a:extLst>
          </p:cNvPr>
          <p:cNvSpPr txBox="1"/>
          <p:nvPr/>
        </p:nvSpPr>
        <p:spPr>
          <a:xfrm>
            <a:off x="1878946" y="1915763"/>
            <a:ext cx="27478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HER2-positive proportion 79 % (0.70, 0.74)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137CDDF-BEE9-CDDB-3216-71B6BFAA5436}"/>
              </a:ext>
            </a:extLst>
          </p:cNvPr>
          <p:cNvSpPr txBox="1"/>
          <p:nvPr/>
        </p:nvSpPr>
        <p:spPr>
          <a:xfrm>
            <a:off x="3789085" y="4696014"/>
            <a:ext cx="15343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time: </a:t>
            </a:r>
            <a:r>
              <a:rPr lang="en-US" altLang="ja-JP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OS</a:t>
            </a: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8.1 months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タイトル 1">
            <a:extLst>
              <a:ext uri="{FF2B5EF4-FFF2-40B4-BE49-F238E27FC236}">
                <a16:creationId xmlns:a16="http://schemas.microsoft.com/office/drawing/2014/main" id="{3C8EF4A3-F32D-2F13-70AB-6F7079F464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0"/>
            <a:ext cx="10515600" cy="1325563"/>
          </a:xfrm>
        </p:spPr>
        <p:txBody>
          <a:bodyPr>
            <a:normAutofit/>
          </a:bodyPr>
          <a:lstStyle/>
          <a:p>
            <a:r>
              <a:rPr kumimoji="1" lang="en-US" altLang="ja-JP" sz="2400" dirty="0">
                <a:latin typeface="Calibri" panose="020F0502020204030204" pitchFamily="34" charset="0"/>
                <a:cs typeface="Calibri" panose="020F0502020204030204" pitchFamily="34" charset="0"/>
              </a:rPr>
              <a:t>Figure S1.</a:t>
            </a:r>
            <a:endParaRPr kumimoji="1" lang="ja-JP" altLang="en-US" sz="2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6" name="図 5" descr="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17DA05A2-04E3-E71B-02FA-560305F7D56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1295400"/>
            <a:ext cx="4267200" cy="4267200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58B681B-5C92-EE81-E848-804EB363E656}"/>
              </a:ext>
            </a:extLst>
          </p:cNvPr>
          <p:cNvSpPr txBox="1"/>
          <p:nvPr/>
        </p:nvSpPr>
        <p:spPr>
          <a:xfrm>
            <a:off x="8512299" y="4696015"/>
            <a:ext cx="15343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time: </a:t>
            </a:r>
            <a:r>
              <a:rPr lang="en-US" altLang="ja-JP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OS</a:t>
            </a: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8.1 months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17C86B2-C21A-7041-8FD6-D1EA07A81A48}"/>
              </a:ext>
            </a:extLst>
          </p:cNvPr>
          <p:cNvSpPr txBox="1"/>
          <p:nvPr/>
        </p:nvSpPr>
        <p:spPr>
          <a:xfrm>
            <a:off x="6602160" y="1915763"/>
            <a:ext cx="17732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TFI 5.8 months (0.75, 0.61)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0E67315-5185-AB67-AB01-858B84667A6B}"/>
              </a:ext>
            </a:extLst>
          </p:cNvPr>
          <p:cNvSpPr txBox="1"/>
          <p:nvPr/>
        </p:nvSpPr>
        <p:spPr>
          <a:xfrm>
            <a:off x="1346200" y="1057113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E3A6F90-1FDA-4A66-0145-CF773D7C7698}"/>
              </a:ext>
            </a:extLst>
          </p:cNvPr>
          <p:cNvSpPr txBox="1"/>
          <p:nvPr/>
        </p:nvSpPr>
        <p:spPr>
          <a:xfrm>
            <a:off x="6110054" y="105711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2F6149C-C790-08FD-3EB2-FA697016946E}"/>
              </a:ext>
            </a:extLst>
          </p:cNvPr>
          <p:cNvSpPr txBox="1"/>
          <p:nvPr/>
        </p:nvSpPr>
        <p:spPr>
          <a:xfrm rot="16200000">
            <a:off x="1061808" y="3285610"/>
            <a:ext cx="76014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ensitivity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23FCEC1-1A81-FD51-84BD-B4212F329267}"/>
              </a:ext>
            </a:extLst>
          </p:cNvPr>
          <p:cNvSpPr txBox="1"/>
          <p:nvPr/>
        </p:nvSpPr>
        <p:spPr>
          <a:xfrm rot="16200000">
            <a:off x="5818719" y="3305889"/>
            <a:ext cx="76014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ensitivity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AD8CF72-ED42-5EF9-E954-ECE1A90F6984}"/>
              </a:ext>
            </a:extLst>
          </p:cNvPr>
          <p:cNvSpPr txBox="1"/>
          <p:nvPr/>
        </p:nvSpPr>
        <p:spPr>
          <a:xfrm>
            <a:off x="3182199" y="5222560"/>
            <a:ext cx="76014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pecificity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677EE5F-A07B-CCAE-B86D-D59E9EF04E12}"/>
              </a:ext>
            </a:extLst>
          </p:cNvPr>
          <p:cNvSpPr txBox="1"/>
          <p:nvPr/>
        </p:nvSpPr>
        <p:spPr>
          <a:xfrm>
            <a:off x="7924887" y="5222559"/>
            <a:ext cx="76014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pecificity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665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</Words>
  <Application>Microsoft Macintosh PowerPoint</Application>
  <PresentationFormat>ワイド画面</PresentationFormat>
  <Paragraphs>1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Figure S1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oichiro Yoshino</dc:creator>
  <cp:lastModifiedBy>Koichiro Yoshino</cp:lastModifiedBy>
  <cp:revision>1</cp:revision>
  <dcterms:created xsi:type="dcterms:W3CDTF">2026-01-20T00:24:27Z</dcterms:created>
  <dcterms:modified xsi:type="dcterms:W3CDTF">2026-01-20T00:24:38Z</dcterms:modified>
</cp:coreProperties>
</file>